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7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>
        <p:scale>
          <a:sx n="201" d="100"/>
          <a:sy n="201" d="100"/>
        </p:scale>
        <p:origin x="776" y="-6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460014-EC34-1548-9FB8-4F8B94B69AE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6362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7D43ED-48ED-9867-948A-C5A184854A6F}"/>
              </a:ext>
            </a:extLst>
          </p:cNvPr>
          <p:cNvSpPr txBox="1"/>
          <p:nvPr/>
        </p:nvSpPr>
        <p:spPr>
          <a:xfrm>
            <a:off x="0" y="0"/>
            <a:ext cx="23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9570B7-DF27-FBC5-1D6B-4AF3EE073E6D}"/>
              </a:ext>
            </a:extLst>
          </p:cNvPr>
          <p:cNvSpPr txBox="1"/>
          <p:nvPr/>
        </p:nvSpPr>
        <p:spPr>
          <a:xfrm>
            <a:off x="0" y="2716409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ABBA8B-65F8-19B4-4668-64318594F2B5}"/>
              </a:ext>
            </a:extLst>
          </p:cNvPr>
          <p:cNvSpPr txBox="1"/>
          <p:nvPr/>
        </p:nvSpPr>
        <p:spPr>
          <a:xfrm>
            <a:off x="-4559" y="568751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97834F-0269-7AA0-5BBE-CD8E9C45AB7E}"/>
              </a:ext>
            </a:extLst>
          </p:cNvPr>
          <p:cNvSpPr txBox="1"/>
          <p:nvPr/>
        </p:nvSpPr>
        <p:spPr>
          <a:xfrm>
            <a:off x="-4" y="4043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49AE9241-66B9-4F22-667C-CC806FB72B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558" y="404334"/>
            <a:ext cx="3176524" cy="254121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99FD051-92E3-853F-808B-E518CA5235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3212" y="404334"/>
            <a:ext cx="3176524" cy="254121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C959567-90CF-DFFF-48C8-77AF7423AC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4559" y="3120744"/>
            <a:ext cx="3176525" cy="254122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C1F53F7-1EAF-92AE-C48C-6406B604C2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83212" y="3120743"/>
            <a:ext cx="3176527" cy="2541221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06FDFA9F-9D8B-DDDE-38D1-17A09B9E4A95}"/>
              </a:ext>
            </a:extLst>
          </p:cNvPr>
          <p:cNvGrpSpPr/>
          <p:nvPr/>
        </p:nvGrpSpPr>
        <p:grpSpPr>
          <a:xfrm>
            <a:off x="303539" y="5885440"/>
            <a:ext cx="4669464" cy="2449581"/>
            <a:chOff x="841962" y="644289"/>
            <a:chExt cx="5101210" cy="267607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346C113-0CFF-F336-FCF3-8F2220195F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2149"/>
            <a:stretch/>
          </p:blipFill>
          <p:spPr>
            <a:xfrm>
              <a:off x="2311689" y="644289"/>
              <a:ext cx="3631483" cy="2676073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99C22E8-F7C3-E771-BD35-EFC556FCFAAB}"/>
                </a:ext>
              </a:extLst>
            </p:cNvPr>
            <p:cNvSpPr/>
            <p:nvPr/>
          </p:nvSpPr>
          <p:spPr>
            <a:xfrm>
              <a:off x="1227015" y="651504"/>
              <a:ext cx="1143115" cy="3693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 CD4+ Tfh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5B0AA91-AD8E-E8FF-3AB3-A184CAC595E7}"/>
                </a:ext>
              </a:extLst>
            </p:cNvPr>
            <p:cNvSpPr/>
            <p:nvPr/>
          </p:nvSpPr>
          <p:spPr>
            <a:xfrm>
              <a:off x="900122" y="895243"/>
              <a:ext cx="1482404" cy="3693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CD8+ Tpre-ex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FF91E39-B98C-CF98-99C1-9B2008B4C6D6}"/>
                </a:ext>
              </a:extLst>
            </p:cNvPr>
            <p:cNvSpPr txBox="1"/>
            <p:nvPr/>
          </p:nvSpPr>
          <p:spPr>
            <a:xfrm>
              <a:off x="981766" y="1170051"/>
              <a:ext cx="13883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CD8+ Ttrm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FFE20C4-F730-AC82-1E9D-AF2DC4A761A1}"/>
                </a:ext>
              </a:extLst>
            </p:cNvPr>
            <p:cNvSpPr txBox="1"/>
            <p:nvPr/>
          </p:nvSpPr>
          <p:spPr>
            <a:xfrm>
              <a:off x="841962" y="1427739"/>
              <a:ext cx="15405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CD8+ Texh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E7969B3-12DC-C894-72CD-0104ED53965E}"/>
                </a:ext>
              </a:extLst>
            </p:cNvPr>
            <p:cNvSpPr txBox="1"/>
            <p:nvPr/>
          </p:nvSpPr>
          <p:spPr>
            <a:xfrm>
              <a:off x="841962" y="1676782"/>
              <a:ext cx="15405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D8+ Teff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76CEAFF-A82E-8847-931E-197B31633293}"/>
                </a:ext>
              </a:extLst>
            </p:cNvPr>
            <p:cNvSpPr txBox="1"/>
            <p:nvPr/>
          </p:nvSpPr>
          <p:spPr>
            <a:xfrm>
              <a:off x="841962" y="1944173"/>
              <a:ext cx="15405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D8+ Teff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E24AA21-1B84-22EE-A6C9-B9DF01F935A5}"/>
                </a:ext>
              </a:extLst>
            </p:cNvPr>
            <p:cNvSpPr txBox="1"/>
            <p:nvPr/>
          </p:nvSpPr>
          <p:spPr>
            <a:xfrm>
              <a:off x="847273" y="2189433"/>
              <a:ext cx="15405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D4+ Treg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D677A41-48C0-8179-FCD4-AC7C1B6656EB}"/>
                </a:ext>
              </a:extLst>
            </p:cNvPr>
            <p:cNvSpPr txBox="1"/>
            <p:nvPr/>
          </p:nvSpPr>
          <p:spPr>
            <a:xfrm>
              <a:off x="860076" y="2424670"/>
              <a:ext cx="1540564" cy="3350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FI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FI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D4+ Tcytotoxic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DF841C4B-FA02-C5D0-84C2-C5E52175A07A}"/>
              </a:ext>
            </a:extLst>
          </p:cNvPr>
          <p:cNvSpPr txBox="1"/>
          <p:nvPr/>
        </p:nvSpPr>
        <p:spPr>
          <a:xfrm>
            <a:off x="-4560" y="8314523"/>
            <a:ext cx="686255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300"/>
              </a:spcBef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</a:p>
          <a:p>
            <a:pPr lvl="0">
              <a:spcBef>
                <a:spcPts val="300"/>
              </a:spcBef>
            </a:pP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15. Enriched GO pathways in pre-REP TIL and REP </a:t>
            </a:r>
            <a:r>
              <a:rPr lang="en-US" sz="800" b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IL cells and </a:t>
            </a: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henotypes of T cells with RCC associated motifs</a:t>
            </a:r>
            <a:endParaRPr lang="en-US" sz="8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op 15 GO pathways enriched in the pre-REP TILs (blue, left panel) and REP TILs (red, right panel) for pt115. T-cell activation and response to IFN-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ere among the top enriched pathways. Pathways related to cytokine production and T-cell differentiation were enriched in the REP TILs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op 15 GO pathways enriched in pt616 pre-REP TILs (blue, left panel) and REP TILs (red, right panel). T-cell activation and regulation were among the top enriched pathways in the pre-REP TILs. Cellular pathways related to co-translational protein targeting were enriched in the REP TILs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dds ratio (OR) plot showing the abundance of T-cell clusters from the UMAP (Fig. 6A) in each tumor sample (pt115, pt423, pt616). RCC-associated motifs in pt115 were highly concentrated in the CD4+ follicular helper T-cell (T</a:t>
            </a:r>
            <a:r>
              <a:rPr lang="en-US" sz="8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H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compartment (cluster 7), pt423 displayed a CD8+ exhausted T-cell (T</a:t>
            </a:r>
            <a:r>
              <a:rPr lang="en-US" sz="8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XH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phenotype (cluster 1), and the motifs for pt616 were concentrated most for the CD8+ pre-exhausted T-cell (T</a:t>
            </a:r>
            <a:r>
              <a:rPr lang="en-US" sz="8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RE-EXH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phenotype (cluster2) (Fig. 5A, 6D)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0092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0</TotalTime>
  <Words>269</Words>
  <Application>Microsoft Macintosh PowerPoint</Application>
  <PresentationFormat>A4-paperi (210 x 297 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6</cp:revision>
  <dcterms:created xsi:type="dcterms:W3CDTF">2022-10-13T13:05:53Z</dcterms:created>
  <dcterms:modified xsi:type="dcterms:W3CDTF">2023-06-17T07:44:05Z</dcterms:modified>
</cp:coreProperties>
</file>